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0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6" d="100"/>
          <a:sy n="106" d="100"/>
        </p:scale>
        <p:origin x="204" y="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8BBDB9D-5462-40A8-93A1-839DE3B270D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A66816C-46F6-4FA5-A1D9-D7A5A163A63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29EF212-EAB9-4BDE-9BE8-73C934BE9A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2D0C7-139A-4B15-BAE5-82677BB12F0D}" type="datetimeFigureOut">
              <a:rPr lang="zh-CN" altLang="en-US" smtClean="0"/>
              <a:t>2022-06-0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B075553-8ABF-4E3D-AD3D-9632348822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E72C009-DFBD-4DB2-8FB0-CF345DA70A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DDB4E-7066-42DE-92C9-302A27D18B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91261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B90CB05-15FE-4138-90FD-8C918F30DE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0C854CB-2ACE-46B8-9ED2-EFA5DA2A12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F6479C7-1765-41E6-94F0-8F546BE308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2D0C7-139A-4B15-BAE5-82677BB12F0D}" type="datetimeFigureOut">
              <a:rPr lang="zh-CN" altLang="en-US" smtClean="0"/>
              <a:t>2022-06-0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EB853AA-B505-42B9-8413-53CBC7AE4F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F1710F4-3682-412A-8335-44530CB66D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DDB4E-7066-42DE-92C9-302A27D18B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31893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366D480A-5F11-4BC1-AA92-478351E3931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B3DE121-FB4C-4960-915D-CB1EC4677D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360B030-FEDD-4781-BD24-43BBDD610F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2D0C7-139A-4B15-BAE5-82677BB12F0D}" type="datetimeFigureOut">
              <a:rPr lang="zh-CN" altLang="en-US" smtClean="0"/>
              <a:t>2022-06-0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8BE1CD2-C1BE-4D48-AED6-AF12DB9E64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646063E-5531-4803-8DB7-B3596F7E00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DDB4E-7066-42DE-92C9-302A27D18B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44254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74400A2-2D7A-4FB3-B464-12E759D464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61D8BFA-1539-4700-BB43-E4D8FAECE3D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F3B2DE9-0623-4F0C-92DB-E03B71455C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2D0C7-139A-4B15-BAE5-82677BB12F0D}" type="datetimeFigureOut">
              <a:rPr lang="zh-CN" altLang="en-US" smtClean="0"/>
              <a:t>2022-06-0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D9D707F-EA0A-44D8-B2D5-C2F6DF07BD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E05056F-0E7B-4BB9-889C-B1AF619ACB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DDB4E-7066-42DE-92C9-302A27D18B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72739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09612DB-53A1-442E-88CD-9494DC3CBA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9D73EFC-3A8D-487F-BE18-531F4AD5B1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EDE8071-CFD1-4BFB-9761-C13B18C6C1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2D0C7-139A-4B15-BAE5-82677BB12F0D}" type="datetimeFigureOut">
              <a:rPr lang="zh-CN" altLang="en-US" smtClean="0"/>
              <a:t>2022-06-0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A81BB41-4A74-4510-BFEA-21A71620AB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ACE1A94-E5E1-488E-BE38-C78802F6DE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DDB4E-7066-42DE-92C9-302A27D18B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25523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E45A2D1-85E2-491C-9242-3E42B80CFA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4B089CC-D5E2-4BDA-939E-E0891678823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23665D6-3D8F-46FB-ABD0-16B4C4A113A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0DEE77D-D95A-4A1F-8783-E481532A6D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2D0C7-139A-4B15-BAE5-82677BB12F0D}" type="datetimeFigureOut">
              <a:rPr lang="zh-CN" altLang="en-US" smtClean="0"/>
              <a:t>2022-06-0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503897F-DD80-4635-BC51-6D0DBC52B5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326A58E-64DF-4606-9634-6F2795DBFC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DDB4E-7066-42DE-92C9-302A27D18B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91278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59602C-D5E9-41D0-9A2C-318ACC304E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BD342BF-EB89-43B8-AFD2-59B0E63D41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A4DE949-B82F-423A-B601-D5E3B653F93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0F9F0AD-50DA-4273-B7F8-7318CF8F0DE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4C63F5F-CAD0-4AC2-B72A-1A97FE9B610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0E8F03B-1CBF-43AE-A41E-CAE9187977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2D0C7-139A-4B15-BAE5-82677BB12F0D}" type="datetimeFigureOut">
              <a:rPr lang="zh-CN" altLang="en-US" smtClean="0"/>
              <a:t>2022-06-0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61CDC2C-4EB0-4388-A01D-969D0F7CB8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C8F63A8-EC38-4210-AB77-28E625866D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DDB4E-7066-42DE-92C9-302A27D18B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89914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F4F70C6-A0EC-4956-A2A3-3F4E3BFC8B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F117FC7B-D97C-4D2E-9295-E716F592C7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2D0C7-139A-4B15-BAE5-82677BB12F0D}" type="datetimeFigureOut">
              <a:rPr lang="zh-CN" altLang="en-US" smtClean="0"/>
              <a:t>2022-06-0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43AC1EC3-E659-4D60-A8D9-4D1CFD959E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EEBD6CDC-E131-4AE2-A7A4-A3C3C5998E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DDB4E-7066-42DE-92C9-302A27D18B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81006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BEF4444-5C38-4993-A5FC-E360A1CAE4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2D0C7-139A-4B15-BAE5-82677BB12F0D}" type="datetimeFigureOut">
              <a:rPr lang="zh-CN" altLang="en-US" smtClean="0"/>
              <a:t>2022-06-0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ADD121C-B8CC-4CEB-B0C1-287A5968D0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3BF5AA5E-5197-4F55-ADFA-73F2D0F5E7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DDB4E-7066-42DE-92C9-302A27D18B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66579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14830A1-2BA1-432D-8728-EDD0D9CF0A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C8B004D-4682-4249-9859-6415EF61D0E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3A53017-E68E-496A-8C80-58E25CB843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CC894C4-8046-433F-930B-D88CB249E2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2D0C7-139A-4B15-BAE5-82677BB12F0D}" type="datetimeFigureOut">
              <a:rPr lang="zh-CN" altLang="en-US" smtClean="0"/>
              <a:t>2022-06-0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4B90EBD-B2DD-472F-B723-5FB977BDB4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29832DC-926F-4B90-B796-B1A991B03C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DDB4E-7066-42DE-92C9-302A27D18B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07756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2BA6F1F-9E0C-4260-83DA-9507886137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18AA368-DBE4-434E-9728-2DA13096F75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9DFAB64-9BBF-4DB6-9012-B6A82C07632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00D027D-036B-4643-BA37-B83884B5B2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2D0C7-139A-4B15-BAE5-82677BB12F0D}" type="datetimeFigureOut">
              <a:rPr lang="zh-CN" altLang="en-US" smtClean="0"/>
              <a:t>2022-06-0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820F49A-FF3D-472D-8538-76AE5A2554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4B79A3D-BF8F-4FC6-8205-81A76231CB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DDB4E-7066-42DE-92C9-302A27D18B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91859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41B08EC-10F1-4B84-8A88-82A4E3BE68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AE5B5CF-2AF4-4314-B3B0-A8B1039013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D778652-10DB-4CC7-A6A3-620391BD162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D2D0C7-139A-4B15-BAE5-82677BB12F0D}" type="datetimeFigureOut">
              <a:rPr lang="zh-CN" altLang="en-US" smtClean="0"/>
              <a:t>2022-06-0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F0FDE01-FE00-4792-9531-06B78FEF749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1EFF9C1-F5D5-4E9F-B61D-DFB3FE72F16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5DDB4E-7066-42DE-92C9-302A27D18B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77466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316932D7-A4CB-49EE-A9EA-2B52736811D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13775" y="0"/>
            <a:ext cx="6541467" cy="5930554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5C2D835A-CC84-4F82-B7D3-056AB21FE8C7}"/>
              </a:ext>
            </a:extLst>
          </p:cNvPr>
          <p:cNvSpPr txBox="1"/>
          <p:nvPr/>
        </p:nvSpPr>
        <p:spPr>
          <a:xfrm>
            <a:off x="2838450" y="6130089"/>
            <a:ext cx="90898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ea typeface="等线" panose="02010600030101010101" pitchFamily="2" charset="-122"/>
              </a:rPr>
              <a:t>Figure S1: 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The correlations between the five eRNAs 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37963842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2DA691B0-A910-4A85-B983-7C8E4CA36F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3000" y="0"/>
            <a:ext cx="8325853" cy="5764052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65E89808-28A7-49B0-89F9-A5600B52D862}"/>
              </a:ext>
            </a:extLst>
          </p:cNvPr>
          <p:cNvSpPr txBox="1"/>
          <p:nvPr/>
        </p:nvSpPr>
        <p:spPr>
          <a:xfrm>
            <a:off x="1515979" y="5967662"/>
            <a:ext cx="90898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ea typeface="等线" panose="02010600030101010101" pitchFamily="2" charset="-122"/>
              </a:rPr>
              <a:t>Figure S2: </a:t>
            </a:r>
            <a:r>
              <a:rPr lang="en-US" altLang="zh-CN" sz="18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The immune cell infiltration levels between the high- and low-risk subgroups.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6523601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AC6C7BC7-6874-44E3-AE05-5277D70D8F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14817" y="234616"/>
            <a:ext cx="6148710" cy="5098369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99332672-93E7-4C2F-A1FD-F2AE8A728568}"/>
              </a:ext>
            </a:extLst>
          </p:cNvPr>
          <p:cNvSpPr txBox="1"/>
          <p:nvPr/>
        </p:nvSpPr>
        <p:spPr>
          <a:xfrm>
            <a:off x="2814817" y="5877425"/>
            <a:ext cx="90898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ea typeface="等线" panose="02010600030101010101" pitchFamily="2" charset="-122"/>
              </a:rPr>
              <a:t>Figure S3: </a:t>
            </a:r>
            <a:r>
              <a:rPr lang="en-US" altLang="zh-CN" sz="18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The immune functions between the high- and low-risk subgroups.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1291730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37</Words>
  <Application>Microsoft Office PowerPoint</Application>
  <PresentationFormat>宽屏</PresentationFormat>
  <Paragraphs>3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7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李 沁雨</dc:creator>
  <cp:lastModifiedBy>李 沁雨</cp:lastModifiedBy>
  <cp:revision>6</cp:revision>
  <dcterms:created xsi:type="dcterms:W3CDTF">2022-05-13T03:40:28Z</dcterms:created>
  <dcterms:modified xsi:type="dcterms:W3CDTF">2022-06-08T02:59:34Z</dcterms:modified>
</cp:coreProperties>
</file>